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metadata" ContentType="application/binary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 xmlns=""/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8" roundtripDataSignature="AMtx7miMU5fVaecWY7ayjyKPBruTNkM3F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DA83DDB9-EC63-4B7C-8465-C6403D876F96}">
  <a:tblStyle styleId="{DA83DDB9-EC63-4B7C-8465-C6403D876F96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8EBF5"/>
          </a:solidFill>
        </a:fill>
      </a:tcStyle>
    </a:wholeTbl>
    <a:band1H>
      <a:tcTxStyle/>
      <a:tcStyle>
        <a:tcBdr/>
        <a:fill>
          <a:solidFill>
            <a:srgbClr val="CDD4EA"/>
          </a:solidFill>
        </a:fill>
      </a:tcStyle>
    </a:band1H>
    <a:band2H>
      <a:tcTxStyle/>
      <a:tcStyle>
        <a:tcBdr/>
      </a:tcStyle>
    </a:band2H>
    <a:band1V>
      <a:tcTxStyle/>
      <a:tcStyle>
        <a:tcBdr/>
        <a:fill>
          <a:solidFill>
            <a:srgbClr val="CDD4EA"/>
          </a:solidFill>
        </a:fill>
      </a:tcStyle>
    </a:band1V>
    <a:band2V>
      <a:tcTxStyle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2C3963EB-107A-4E9B-8004-930B0A60BB1F}" styleName="Table_1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-606" y="-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3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10" Type="http://schemas.openxmlformats.org/officeDocument/2006/relationships/viewProps" Target="viewProps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pPr marL="0" marR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86" name="Google Shape;86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87" name="Google Shape;87;p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1</a:t>
            </a:fld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4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4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4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4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6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6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7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8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8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3" name="Google Shape;43;p8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8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5" name="Google Shape;45;p8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1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1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1" name="Google Shape;61;p11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2" name="Google Shape;62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2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2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2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9" name="Google Shape;69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3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3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9" name="Google Shape;89;p1"/>
          <p:cNvGraphicFramePr/>
          <p:nvPr/>
        </p:nvGraphicFramePr>
        <p:xfrm>
          <a:off x="1412240" y="689186"/>
          <a:ext cx="9428500" cy="3977740"/>
        </p:xfrm>
        <a:graphic>
          <a:graphicData uri="http://schemas.openxmlformats.org/drawingml/2006/table">
            <a:tbl>
              <a:tblPr firstRow="1" bandRow="1">
                <a:noFill/>
                <a:tableStyleId>{DA83DDB9-EC63-4B7C-8465-C6403D876F96}</a:tableStyleId>
              </a:tblPr>
              <a:tblGrid>
                <a:gridCol w="173490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206900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398025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134112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37905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150640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</a:tblGrid>
              <a:tr h="3708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u="none" strike="noStrike" cap="none"/>
                        <a:t>Time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Monday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Tuesday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Wednesday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Thursday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Friday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708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dirty="0"/>
                        <a:t>8-9am</a:t>
                      </a:r>
                      <a:endParaRPr dirty="0"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4"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dirty="0"/>
                        <a:t>Research</a:t>
                      </a:r>
                      <a:endParaRPr sz="1800" dirty="0"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BE5"/>
                    </a:solidFill>
                  </a:tcPr>
                </a:tc>
                <a:tc rowSpan="4"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Font typeface="Arial"/>
                        <a:buNone/>
                      </a:pPr>
                      <a:r>
                        <a:rPr lang="en-US" sz="1800"/>
                        <a:t>Research</a:t>
                      </a:r>
                      <a:endParaRPr sz="1800"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BE5"/>
                    </a:solidFill>
                  </a:tcPr>
                </a:tc>
                <a:tc rowSpan="4"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Font typeface="Arial"/>
                        <a:buNone/>
                      </a:pPr>
                      <a:r>
                        <a:rPr lang="en-US" sz="1800"/>
                        <a:t>Research</a:t>
                      </a:r>
                      <a:endParaRPr sz="1800"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BE5"/>
                    </a:solidFill>
                  </a:tcPr>
                </a:tc>
                <a:tc rowSpan="4"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Font typeface="Arial"/>
                        <a:buNone/>
                      </a:pPr>
                      <a:r>
                        <a:rPr lang="en-US" sz="1800"/>
                        <a:t>Research</a:t>
                      </a:r>
                      <a:endParaRPr sz="1800"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BE5"/>
                    </a:solidFill>
                  </a:tcPr>
                </a:tc>
                <a:tc rowSpan="4"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Font typeface="Arial"/>
                        <a:buNone/>
                      </a:pPr>
                      <a:r>
                        <a:rPr lang="en-US" sz="1800"/>
                        <a:t>Research</a:t>
                      </a:r>
                      <a:endParaRPr sz="1800"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B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708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9-10am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708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10-11am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708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11-12pm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708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12-1pm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Lunch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Lunch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Lunch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Lunch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Lunch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3708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1-2pm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3"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Font typeface="Arial"/>
                        <a:buNone/>
                      </a:pPr>
                      <a:r>
                        <a:rPr lang="en-US" sz="1800"/>
                        <a:t>Research</a:t>
                      </a:r>
                      <a:endParaRPr sz="1800"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BE5"/>
                    </a:solidFill>
                  </a:tcPr>
                </a:tc>
                <a:tc rowSpan="4"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>
                          <a:solidFill>
                            <a:schemeClr val="dk1"/>
                          </a:solidFill>
                          <a:latin typeface="Calibri"/>
                          <a:ea typeface="Calibri"/>
                          <a:cs typeface="Calibri"/>
                          <a:sym typeface="Calibri"/>
                        </a:rPr>
                        <a:t>Research</a:t>
                      </a:r>
                      <a:endParaRPr sz="1800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800">
                        <a:solidFill>
                          <a:schemeClr val="dk1"/>
                        </a:solidFill>
                        <a:latin typeface="Calibri"/>
                        <a:ea typeface="Calibri"/>
                        <a:cs typeface="Calibri"/>
                        <a:sym typeface="Calibri"/>
                      </a:endParaRPr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BE5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Font typeface="Arial"/>
                        <a:buNone/>
                      </a:pPr>
                      <a:r>
                        <a:rPr lang="en-US" sz="1800"/>
                        <a:t>Research</a:t>
                      </a:r>
                      <a:endParaRPr sz="1800"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BE5"/>
                    </a:solidFill>
                  </a:tcPr>
                </a:tc>
                <a:tc rowSpan="4"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Font typeface="Arial"/>
                        <a:buNone/>
                      </a:pPr>
                      <a:r>
                        <a:rPr lang="en-US" sz="1800"/>
                        <a:t>Research</a:t>
                      </a:r>
                      <a:endParaRPr sz="1800"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BE5"/>
                    </a:solidFill>
                  </a:tcPr>
                </a:tc>
                <a:tc rowSpan="3">
                  <a:txBody>
                    <a:bodyPr/>
                    <a:lstStyle/>
                    <a:p>
                      <a:pPr marL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Font typeface="Arial"/>
                        <a:buNone/>
                      </a:pPr>
                      <a:r>
                        <a:rPr lang="en-US" sz="1800"/>
                        <a:t>Research</a:t>
                      </a:r>
                      <a:endParaRPr sz="1800"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D5DBE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3708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2-3pm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3708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3-4pm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370850"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4-5pm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Professional Development Talk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7CAAC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/>
                        <a:t>Journal Club</a:t>
                      </a:r>
                      <a:endParaRPr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E1EFD8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rtl="0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800" dirty="0"/>
                        <a:t>Social Hour</a:t>
                      </a:r>
                      <a:endParaRPr dirty="0"/>
                    </a:p>
                  </a:txBody>
                  <a:tcPr marL="91450" marR="91450" marT="45725" marB="45725">
                    <a:lnL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>
                      <a:solidFill>
                        <a:schemeClr val="dk1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  <a:solidFill>
                      <a:srgbClr val="FFF2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</a:tbl>
          </a:graphicData>
        </a:graphic>
      </p:graphicFrame>
      <p:sp>
        <p:nvSpPr>
          <p:cNvPr id="90" name="Google Shape;90;p1"/>
          <p:cNvSpPr txBox="1"/>
          <p:nvPr/>
        </p:nvSpPr>
        <p:spPr>
          <a:xfrm>
            <a:off x="2940333" y="4973468"/>
            <a:ext cx="6311333" cy="6462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Sample weekly schedule illustrating the summer research programming. </a:t>
            </a:r>
          </a:p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0" i="0" u="none" strike="noStrike" cap="none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Potential Professional Development Topics: imposter syndrome, leveraging mentoring, navigating physician-scientists training pathway as student with an underrepresented identity</a:t>
            </a:r>
            <a:endParaRPr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72</Words>
  <Application>Microsoft Office PowerPoint</Application>
  <PresentationFormat>Custom</PresentationFormat>
  <Paragraphs>3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o Barrere-Cain</dc:creator>
  <cp:lastModifiedBy>sundari.ka</cp:lastModifiedBy>
  <cp:revision>3</cp:revision>
  <dcterms:created xsi:type="dcterms:W3CDTF">2022-07-03T04:56:09Z</dcterms:created>
  <dcterms:modified xsi:type="dcterms:W3CDTF">2022-09-30T11:46:54Z</dcterms:modified>
</cp:coreProperties>
</file>